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3"/>
  </p:notesMasterIdLst>
  <p:sldIdLst>
    <p:sldId id="299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9523" autoAdjust="0"/>
  </p:normalViewPr>
  <p:slideViewPr>
    <p:cSldViewPr snapToGrid="0">
      <p:cViewPr>
        <p:scale>
          <a:sx n="90" d="100"/>
          <a:sy n="90" d="100"/>
        </p:scale>
        <p:origin x="1008" y="-1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630EB5-7C48-4349-888E-77DE74F97AAD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6248A3-1C91-4D34-B07D-ACA348CF274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81714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8747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9023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946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62449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34957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88766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4197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38459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03396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3301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715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33CA6-1A78-4E37-84BC-DE0B4578B986}" type="datetimeFigureOut">
              <a:rPr lang="en-CA" smtClean="0"/>
              <a:t>2017-11-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19555F-F13A-4427-ABA1-23C43D8718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0897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Rectangle 108">
            <a:extLst>
              <a:ext uri="{FF2B5EF4-FFF2-40B4-BE49-F238E27FC236}">
                <a16:creationId xmlns:a16="http://schemas.microsoft.com/office/drawing/2014/main" id="{4D7FEB14-75C7-4EBA-9296-17646707C4D5}"/>
              </a:ext>
            </a:extLst>
          </p:cNvPr>
          <p:cNvSpPr/>
          <p:nvPr/>
        </p:nvSpPr>
        <p:spPr>
          <a:xfrm>
            <a:off x="514681" y="1768645"/>
            <a:ext cx="7257719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Saf5    326 KLDKEDDEDES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-ETQK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W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K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DP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P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-G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V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Y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W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C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I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K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DPF3    246 H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R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-Q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DGT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IPN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Y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N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R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R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GHP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Q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EA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TY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WQ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CK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I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BAF45a  364 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KS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GY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KVIPNA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GICLKGKESN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G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SLIHCSQ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SGHPSCLDMT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LVSM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TYPWQCMECKTCIICGQ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BAF45A  363 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KS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A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GY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KVIPNA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GICLKGKESN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G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SLIHCSQ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SGHPSCLDMT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LVSM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TYPWQCMECKTCIICGQ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endParaRPr lang="en-CA" sz="800" dirty="0">
              <a:solidFill>
                <a:srgbClr val="000000"/>
              </a:solidFill>
              <a:highlight>
                <a:srgbClr val="FFFFFF"/>
              </a:highlight>
              <a:latin typeface="Courier New" panose="02070309020205020404" pitchFamily="49" charset="0"/>
              <a:ea typeface="Calibri" panose="020F0502020204030204" pitchFamily="34" charset="0"/>
            </a:endParaRPr>
          </a:p>
          <a:p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Saf5    404 NTK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D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DR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PART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IP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RW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CGVLLFQNYS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R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LLKQYSKQQVDNKIICKDCWVYYQ…549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DPF3    325 SEN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D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Q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L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CD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D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DRGYH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Y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NPPV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P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E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W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L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WELLKEKASAF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Q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A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-------------------------…378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hBAF45a  442 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HHEEE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CD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DRGYH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--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AIP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RWICDCCQRAPPTPR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RRGKNSKE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-------------------…498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BAF45A  441 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PHHEEE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MM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CD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CDRGYH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FC</a:t>
            </a:r>
            <a:r>
              <a:rPr lang="en-CA" sz="8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L--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AIP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S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RWICDCCQRAPPTPR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K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V</a:t>
            </a:r>
            <a:r>
              <a:rPr lang="en-CA" sz="8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GRRGKNSKEG</a:t>
            </a:r>
            <a: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  <a:t>--------------------…497</a:t>
            </a:r>
            <a:br>
              <a:rPr lang="en-CA" sz="8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Calibri" panose="020F0502020204030204" pitchFamily="34" charset="0"/>
              </a:rPr>
            </a:br>
            <a:endParaRPr lang="en-CA" dirty="0"/>
          </a:p>
        </p:txBody>
      </p:sp>
      <p:sp>
        <p:nvSpPr>
          <p:cNvPr id="40" name="Text Box 688"/>
          <p:cNvSpPr txBox="1">
            <a:spLocks noChangeArrowheads="1"/>
          </p:cNvSpPr>
          <p:nvPr/>
        </p:nvSpPr>
        <p:spPr bwMode="auto">
          <a:xfrm>
            <a:off x="649372" y="3888816"/>
            <a:ext cx="514350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tSaf5</a:t>
            </a:r>
          </a:p>
        </p:txBody>
      </p:sp>
      <p:sp>
        <p:nvSpPr>
          <p:cNvPr id="41" name="Text Box 689"/>
          <p:cNvSpPr txBox="1">
            <a:spLocks noChangeArrowheads="1"/>
          </p:cNvSpPr>
          <p:nvPr/>
        </p:nvSpPr>
        <p:spPr bwMode="auto">
          <a:xfrm>
            <a:off x="1610632" y="4707927"/>
            <a:ext cx="394660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tSaf5</a:t>
            </a:r>
          </a:p>
        </p:txBody>
      </p:sp>
      <p:sp>
        <p:nvSpPr>
          <p:cNvPr id="42" name="Line 705"/>
          <p:cNvSpPr>
            <a:spLocks noChangeShapeType="1"/>
          </p:cNvSpPr>
          <p:nvPr/>
        </p:nvSpPr>
        <p:spPr bwMode="auto">
          <a:xfrm flipV="1">
            <a:off x="1173247" y="3663117"/>
            <a:ext cx="0" cy="15240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707"/>
          <p:cNvSpPr>
            <a:spLocks noChangeArrowheads="1"/>
          </p:cNvSpPr>
          <p:nvPr/>
        </p:nvSpPr>
        <p:spPr bwMode="auto">
          <a:xfrm>
            <a:off x="4167708" y="3814999"/>
            <a:ext cx="1271587" cy="362486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Line 715"/>
          <p:cNvSpPr>
            <a:spLocks noChangeShapeType="1"/>
          </p:cNvSpPr>
          <p:nvPr/>
        </p:nvSpPr>
        <p:spPr bwMode="auto">
          <a:xfrm>
            <a:off x="2840553" y="4209134"/>
            <a:ext cx="228600" cy="1588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Line 718"/>
          <p:cNvSpPr>
            <a:spLocks noChangeShapeType="1"/>
          </p:cNvSpPr>
          <p:nvPr/>
        </p:nvSpPr>
        <p:spPr bwMode="auto">
          <a:xfrm flipV="1">
            <a:off x="4138164" y="3734173"/>
            <a:ext cx="0" cy="76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 Box 719"/>
          <p:cNvSpPr txBox="1">
            <a:spLocks noChangeArrowheads="1"/>
          </p:cNvSpPr>
          <p:nvPr/>
        </p:nvSpPr>
        <p:spPr bwMode="auto">
          <a:xfrm>
            <a:off x="4013771" y="3513477"/>
            <a:ext cx="22955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7" name="Line 720"/>
          <p:cNvSpPr>
            <a:spLocks noChangeShapeType="1"/>
          </p:cNvSpPr>
          <p:nvPr/>
        </p:nvSpPr>
        <p:spPr bwMode="auto">
          <a:xfrm rot="10658844">
            <a:off x="3881628" y="4217807"/>
            <a:ext cx="233363" cy="635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721"/>
          <p:cNvSpPr>
            <a:spLocks noChangeShapeType="1"/>
          </p:cNvSpPr>
          <p:nvPr/>
        </p:nvSpPr>
        <p:spPr bwMode="auto">
          <a:xfrm>
            <a:off x="4189929" y="4218525"/>
            <a:ext cx="228600" cy="1587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Line 722"/>
          <p:cNvSpPr>
            <a:spLocks noChangeShapeType="1"/>
          </p:cNvSpPr>
          <p:nvPr/>
        </p:nvSpPr>
        <p:spPr bwMode="auto">
          <a:xfrm rot="10658844">
            <a:off x="5188466" y="4211616"/>
            <a:ext cx="234950" cy="9525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Line 726"/>
          <p:cNvSpPr>
            <a:spLocks noChangeShapeType="1"/>
          </p:cNvSpPr>
          <p:nvPr/>
        </p:nvSpPr>
        <p:spPr bwMode="auto">
          <a:xfrm>
            <a:off x="2073185" y="4543393"/>
            <a:ext cx="228600" cy="1587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732"/>
          <p:cNvSpPr>
            <a:spLocks noChangeArrowheads="1"/>
          </p:cNvSpPr>
          <p:nvPr/>
        </p:nvSpPr>
        <p:spPr bwMode="auto">
          <a:xfrm>
            <a:off x="3803134" y="4630278"/>
            <a:ext cx="315913" cy="357346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CA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R</a:t>
            </a:r>
          </a:p>
        </p:txBody>
      </p:sp>
      <p:sp>
        <p:nvSpPr>
          <p:cNvPr id="52" name="Line 734"/>
          <p:cNvSpPr>
            <a:spLocks noChangeShapeType="1"/>
          </p:cNvSpPr>
          <p:nvPr/>
        </p:nvSpPr>
        <p:spPr bwMode="auto">
          <a:xfrm rot="10658844">
            <a:off x="3106380" y="4554505"/>
            <a:ext cx="233363" cy="635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Line 737"/>
          <p:cNvSpPr>
            <a:spLocks noChangeShapeType="1"/>
          </p:cNvSpPr>
          <p:nvPr/>
        </p:nvSpPr>
        <p:spPr bwMode="auto">
          <a:xfrm>
            <a:off x="4126984" y="4783105"/>
            <a:ext cx="1004888" cy="0"/>
          </a:xfrm>
          <a:prstGeom prst="line">
            <a:avLst/>
          </a:prstGeom>
          <a:noFill/>
          <a:ln w="762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Line 745"/>
          <p:cNvSpPr>
            <a:spLocks noChangeShapeType="1"/>
          </p:cNvSpPr>
          <p:nvPr/>
        </p:nvSpPr>
        <p:spPr bwMode="auto">
          <a:xfrm flipV="1">
            <a:off x="5139809" y="4579905"/>
            <a:ext cx="217488" cy="7938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Line 746"/>
          <p:cNvSpPr>
            <a:spLocks noChangeShapeType="1"/>
          </p:cNvSpPr>
          <p:nvPr/>
        </p:nvSpPr>
        <p:spPr bwMode="auto">
          <a:xfrm rot="10658844">
            <a:off x="6168478" y="4586255"/>
            <a:ext cx="234950" cy="9525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747"/>
          <p:cNvSpPr>
            <a:spLocks noChangeArrowheads="1"/>
          </p:cNvSpPr>
          <p:nvPr/>
        </p:nvSpPr>
        <p:spPr bwMode="auto">
          <a:xfrm>
            <a:off x="4288909" y="4427505"/>
            <a:ext cx="51809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i="1">
                <a:latin typeface="Arial" panose="020B0604020202020204" pitchFamily="34" charset="0"/>
                <a:cs typeface="Arial" panose="020B0604020202020204" pitchFamily="34" charset="0"/>
              </a:rPr>
              <a:t>NEO</a:t>
            </a:r>
          </a:p>
        </p:txBody>
      </p:sp>
      <p:sp>
        <p:nvSpPr>
          <p:cNvPr id="57" name="Line 750"/>
          <p:cNvSpPr>
            <a:spLocks noChangeShapeType="1"/>
          </p:cNvSpPr>
          <p:nvPr/>
        </p:nvSpPr>
        <p:spPr bwMode="auto">
          <a:xfrm flipH="1">
            <a:off x="2080924" y="4228549"/>
            <a:ext cx="759627" cy="296403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Line 751"/>
          <p:cNvSpPr>
            <a:spLocks noChangeShapeType="1"/>
          </p:cNvSpPr>
          <p:nvPr/>
        </p:nvSpPr>
        <p:spPr bwMode="auto">
          <a:xfrm flipH="1">
            <a:off x="3339775" y="4246542"/>
            <a:ext cx="769706" cy="301020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Line 752"/>
          <p:cNvSpPr>
            <a:spLocks noChangeShapeType="1"/>
          </p:cNvSpPr>
          <p:nvPr/>
        </p:nvSpPr>
        <p:spPr bwMode="auto">
          <a:xfrm>
            <a:off x="4189930" y="4246541"/>
            <a:ext cx="949880" cy="343173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Line 753"/>
          <p:cNvSpPr>
            <a:spLocks noChangeShapeType="1"/>
          </p:cNvSpPr>
          <p:nvPr/>
        </p:nvSpPr>
        <p:spPr bwMode="auto">
          <a:xfrm>
            <a:off x="5437108" y="4213020"/>
            <a:ext cx="963212" cy="352622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1163723" y="3814730"/>
            <a:ext cx="2969108" cy="3624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2063239" y="4626452"/>
            <a:ext cx="1284283" cy="3624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1173247" y="3668927"/>
            <a:ext cx="250987" cy="380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/>
          <p:cNvSpPr/>
          <p:nvPr/>
        </p:nvSpPr>
        <p:spPr>
          <a:xfrm>
            <a:off x="3365835" y="4626099"/>
            <a:ext cx="418250" cy="3624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ZZ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1983515" y="4334274"/>
            <a:ext cx="431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KpnI</a:t>
            </a:r>
            <a:endParaRPr lang="en-CA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035236" y="4333725"/>
            <a:ext cx="431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XhoI</a:t>
            </a:r>
            <a:endParaRPr lang="en-CA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063792" y="4366674"/>
            <a:ext cx="431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NotI</a:t>
            </a:r>
            <a:endParaRPr lang="en-CA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082968" y="4372399"/>
            <a:ext cx="431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SacI</a:t>
            </a:r>
            <a:endParaRPr lang="en-CA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707"/>
          <p:cNvSpPr>
            <a:spLocks noChangeArrowheads="1"/>
          </p:cNvSpPr>
          <p:nvPr/>
        </p:nvSpPr>
        <p:spPr bwMode="auto">
          <a:xfrm>
            <a:off x="5142190" y="4637015"/>
            <a:ext cx="1271587" cy="362486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732"/>
          <p:cNvSpPr>
            <a:spLocks noChangeArrowheads="1"/>
          </p:cNvSpPr>
          <p:nvPr/>
        </p:nvSpPr>
        <p:spPr bwMode="auto">
          <a:xfrm>
            <a:off x="3926384" y="3821599"/>
            <a:ext cx="50410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32"/>
          <p:cNvSpPr>
            <a:spLocks noChangeArrowheads="1"/>
          </p:cNvSpPr>
          <p:nvPr/>
        </p:nvSpPr>
        <p:spPr bwMode="auto">
          <a:xfrm>
            <a:off x="3266323" y="3824046"/>
            <a:ext cx="162397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32"/>
          <p:cNvSpPr>
            <a:spLocks noChangeArrowheads="1"/>
          </p:cNvSpPr>
          <p:nvPr/>
        </p:nvSpPr>
        <p:spPr bwMode="auto">
          <a:xfrm>
            <a:off x="3724628" y="3823914"/>
            <a:ext cx="45719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2"/>
          <p:cNvSpPr>
            <a:spLocks noChangeArrowheads="1"/>
          </p:cNvSpPr>
          <p:nvPr/>
        </p:nvSpPr>
        <p:spPr bwMode="auto">
          <a:xfrm>
            <a:off x="2880120" y="3827513"/>
            <a:ext cx="58934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32"/>
          <p:cNvSpPr>
            <a:spLocks noChangeArrowheads="1"/>
          </p:cNvSpPr>
          <p:nvPr/>
        </p:nvSpPr>
        <p:spPr bwMode="auto">
          <a:xfrm>
            <a:off x="2200879" y="3824046"/>
            <a:ext cx="201811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 Box 719"/>
          <p:cNvSpPr txBox="1">
            <a:spLocks noChangeArrowheads="1"/>
          </p:cNvSpPr>
          <p:nvPr/>
        </p:nvSpPr>
        <p:spPr bwMode="auto">
          <a:xfrm>
            <a:off x="3659995" y="4339042"/>
            <a:ext cx="22955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0" name="Line 718"/>
          <p:cNvSpPr>
            <a:spLocks noChangeShapeType="1"/>
          </p:cNvSpPr>
          <p:nvPr/>
        </p:nvSpPr>
        <p:spPr bwMode="auto">
          <a:xfrm flipV="1">
            <a:off x="3788838" y="4554078"/>
            <a:ext cx="0" cy="762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732"/>
          <p:cNvSpPr>
            <a:spLocks noChangeArrowheads="1"/>
          </p:cNvSpPr>
          <p:nvPr/>
        </p:nvSpPr>
        <p:spPr bwMode="auto">
          <a:xfrm>
            <a:off x="2612614" y="3816343"/>
            <a:ext cx="76591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732"/>
          <p:cNvSpPr>
            <a:spLocks noChangeArrowheads="1"/>
          </p:cNvSpPr>
          <p:nvPr/>
        </p:nvSpPr>
        <p:spPr bwMode="auto">
          <a:xfrm>
            <a:off x="1798139" y="3814421"/>
            <a:ext cx="62748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732"/>
          <p:cNvSpPr>
            <a:spLocks noChangeArrowheads="1"/>
          </p:cNvSpPr>
          <p:nvPr/>
        </p:nvSpPr>
        <p:spPr bwMode="auto">
          <a:xfrm>
            <a:off x="1661386" y="3820788"/>
            <a:ext cx="45719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732"/>
          <p:cNvSpPr>
            <a:spLocks noChangeArrowheads="1"/>
          </p:cNvSpPr>
          <p:nvPr/>
        </p:nvSpPr>
        <p:spPr bwMode="auto">
          <a:xfrm>
            <a:off x="1540994" y="3824041"/>
            <a:ext cx="50410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732"/>
          <p:cNvSpPr>
            <a:spLocks noChangeArrowheads="1"/>
          </p:cNvSpPr>
          <p:nvPr/>
        </p:nvSpPr>
        <p:spPr bwMode="auto">
          <a:xfrm>
            <a:off x="1339543" y="3824046"/>
            <a:ext cx="45719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Line 715"/>
          <p:cNvSpPr>
            <a:spLocks noChangeShapeType="1"/>
          </p:cNvSpPr>
          <p:nvPr/>
        </p:nvSpPr>
        <p:spPr bwMode="auto">
          <a:xfrm>
            <a:off x="2027247" y="5015641"/>
            <a:ext cx="228600" cy="1588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sm" len="sm"/>
            <a:tailEnd type="stealth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732"/>
          <p:cNvSpPr>
            <a:spLocks noChangeArrowheads="1"/>
          </p:cNvSpPr>
          <p:nvPr/>
        </p:nvSpPr>
        <p:spPr bwMode="auto">
          <a:xfrm>
            <a:off x="3113078" y="4628106"/>
            <a:ext cx="50410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732"/>
          <p:cNvSpPr>
            <a:spLocks noChangeArrowheads="1"/>
          </p:cNvSpPr>
          <p:nvPr/>
        </p:nvSpPr>
        <p:spPr bwMode="auto">
          <a:xfrm>
            <a:off x="2453017" y="4630553"/>
            <a:ext cx="162397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732"/>
          <p:cNvSpPr>
            <a:spLocks noChangeArrowheads="1"/>
          </p:cNvSpPr>
          <p:nvPr/>
        </p:nvSpPr>
        <p:spPr bwMode="auto">
          <a:xfrm>
            <a:off x="2911322" y="4630421"/>
            <a:ext cx="45719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 732"/>
          <p:cNvSpPr>
            <a:spLocks noChangeArrowheads="1"/>
          </p:cNvSpPr>
          <p:nvPr/>
        </p:nvSpPr>
        <p:spPr bwMode="auto">
          <a:xfrm>
            <a:off x="2066814" y="4634020"/>
            <a:ext cx="58934" cy="35642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en-CA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707"/>
          <p:cNvSpPr>
            <a:spLocks noChangeArrowheads="1"/>
          </p:cNvSpPr>
          <p:nvPr/>
        </p:nvSpPr>
        <p:spPr bwMode="auto">
          <a:xfrm>
            <a:off x="4776179" y="3814421"/>
            <a:ext cx="660930" cy="36248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707"/>
          <p:cNvSpPr>
            <a:spLocks noChangeArrowheads="1"/>
          </p:cNvSpPr>
          <p:nvPr/>
        </p:nvSpPr>
        <p:spPr bwMode="auto">
          <a:xfrm>
            <a:off x="5752847" y="4633714"/>
            <a:ext cx="660930" cy="36248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en-CA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13957" y="1170499"/>
            <a:ext cx="3354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304570" y="3205700"/>
            <a:ext cx="3354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  <p:cxnSp>
        <p:nvCxnSpPr>
          <p:cNvPr id="96" name="Straight Connector 95"/>
          <p:cNvCxnSpPr/>
          <p:nvPr/>
        </p:nvCxnSpPr>
        <p:spPr>
          <a:xfrm flipV="1">
            <a:off x="3336349" y="2083274"/>
            <a:ext cx="2870811" cy="4216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>
            <a:cxnSpLocks/>
          </p:cNvCxnSpPr>
          <p:nvPr/>
        </p:nvCxnSpPr>
        <p:spPr>
          <a:xfrm>
            <a:off x="5783887" y="1710532"/>
            <a:ext cx="443055" cy="0"/>
          </a:xfrm>
          <a:prstGeom prst="line">
            <a:avLst/>
          </a:prstGeom>
          <a:ln w="571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807989" y="1478276"/>
            <a:ext cx="6878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b="1" dirty="0">
                <a:latin typeface="Arial" panose="020B0604020202020204" pitchFamily="34" charset="0"/>
                <a:cs typeface="Arial" panose="020B0604020202020204" pitchFamily="34" charset="0"/>
              </a:rPr>
              <a:t>PHD1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2096281" y="2269265"/>
            <a:ext cx="8084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b="1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702E72DC-7BE0-48BC-874B-9152364A5E7A}"/>
              </a:ext>
            </a:extLst>
          </p:cNvPr>
          <p:cNvCxnSpPr>
            <a:cxnSpLocks/>
          </p:cNvCxnSpPr>
          <p:nvPr/>
        </p:nvCxnSpPr>
        <p:spPr>
          <a:xfrm>
            <a:off x="2479296" y="1702445"/>
            <a:ext cx="3286499" cy="8087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7EA7CE9E-5C22-4FBB-BD52-134FECFCC697}"/>
              </a:ext>
            </a:extLst>
          </p:cNvPr>
          <p:cNvCxnSpPr>
            <a:cxnSpLocks/>
          </p:cNvCxnSpPr>
          <p:nvPr/>
        </p:nvCxnSpPr>
        <p:spPr>
          <a:xfrm>
            <a:off x="1380387" y="2487172"/>
            <a:ext cx="2427602" cy="0"/>
          </a:xfrm>
          <a:prstGeom prst="line">
            <a:avLst/>
          </a:prstGeom>
          <a:ln w="571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Rectangle 102">
            <a:extLst>
              <a:ext uri="{FF2B5EF4-FFF2-40B4-BE49-F238E27FC236}">
                <a16:creationId xmlns:a16="http://schemas.microsoft.com/office/drawing/2014/main" id="{C083B289-5A0D-4B1F-8273-81783B09940D}"/>
              </a:ext>
            </a:extLst>
          </p:cNvPr>
          <p:cNvSpPr/>
          <p:nvPr/>
        </p:nvSpPr>
        <p:spPr>
          <a:xfrm>
            <a:off x="349890" y="5437596"/>
            <a:ext cx="6164443" cy="1692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f5: A. </a:t>
            </a:r>
            <a:r>
              <a:rPr lang="en-CA" sz="8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trahymena</a:t>
            </a:r>
            <a:r>
              <a:rPr lang="en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THERM_00241840 (tSaf5) shows homology to human (hBAF45a and hDPF3), and mice (mBAF45a) PHD domains.</a:t>
            </a: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two PHD domains of Saf5 are highly similar to each other (E-value 3e-14) as well as with the PHD domains of mBAF45a and hBAF45a (E-value 7e-14). The Saf5 PHD domains also share an E-value of 2e-15 with respect to the PHD domains of DPF3. The 4 proteins present 2 PHD domains in Tandem (PHD1 and PHD2).</a:t>
            </a:r>
            <a:r>
              <a:rPr lang="en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ustal</a:t>
            </a: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mega Multiple Sequence Alignment from EMBL-EBI, </a:t>
            </a:r>
            <a:r>
              <a:rPr lang="en-CA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Shade</a:t>
            </a: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</a:t>
            </a:r>
            <a:r>
              <a:rPr lang="en-CA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ASy</a:t>
            </a: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SMART from EMBL-HEIDELBERG were used for this figure. 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The start and end of the bromodomains are </a:t>
            </a:r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as follows: 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Saf5, PHD1:344-396 PHD2:397-443; hBAF45a, PHD1:379-434 PHD2:435-479; hDPF3, PHD1:261-317 PHD2:318-364; mBAF45a, PHD1:378-433 PHD2:434-478 (SMART). Ab</a:t>
            </a:r>
            <a:r>
              <a:rPr lang="en-US" alt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olutely</a:t>
            </a:r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onserved residues are represented by a black shade and conserved residues are represented by a grey shade (</a:t>
            </a:r>
            <a:r>
              <a:rPr lang="en-US" alt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oxShade</a:t>
            </a:r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). The last number of last line represents the last residue for the each given sequence. </a:t>
            </a:r>
            <a:r>
              <a:rPr lang="en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 Saf5 Cloning Strategy. </a:t>
            </a: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top panel represents the full gene in the MAC, the bottom panel represents the tagging cassette. The pointed lines represent where DNA replacement occurs. Arrows represent the used primers </a:t>
            </a:r>
            <a:r>
              <a:rPr lang="en-CA" sz="8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dditional File 4). </a:t>
            </a:r>
            <a:r>
              <a:rPr lang="en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ack boxes are not coding sequences. White boxes are coding sequences. Bended arrow represents the starting codon and * represents the stop codons.</a:t>
            </a:r>
            <a:endParaRPr lang="en-US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1803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34</TotalTime>
  <Words>272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Saettone</dc:creator>
  <cp:lastModifiedBy>uBioDiscovery</cp:lastModifiedBy>
  <cp:revision>274</cp:revision>
  <dcterms:created xsi:type="dcterms:W3CDTF">2015-09-04T13:41:12Z</dcterms:created>
  <dcterms:modified xsi:type="dcterms:W3CDTF">2017-11-21T17:53:42Z</dcterms:modified>
</cp:coreProperties>
</file>